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FA1D0B-20F6-44E0-B76A-4761758250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FEBB9-EAD0-4946-854C-A0FEC82781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4B88C2-19D6-47B7-BD4C-A9F5F8FEC2B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424B0-0DE1-4E76-BDB5-3EF68B087F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54D28-73A2-4ECA-B2AB-A6F8E609BC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B7A2C-6267-49CF-AF75-306D9DA951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FB5F70-42CE-4055-8D45-A08307D5B2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842E8-2687-4353-9301-FBF85EB7D3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CE3DDE-D43F-4FF8-B67E-2CDCE5D868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8CF01-077F-450B-8458-66CB0B71FE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00693A-31CF-49B1-8783-336D95A5E1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0F93EC-FFEA-43E8-AD57-BD0A99DC0F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D28CA6-6330-4475-904D-BF87B105C0C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"/>
          <p:cNvSpPr/>
          <p:nvPr/>
        </p:nvSpPr>
        <p:spPr>
          <a:xfrm>
            <a:off x="6659640" y="741240"/>
            <a:ext cx="2376360" cy="329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8. Overlapping PCR assays of plasmid carrying the variant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gene in four isolates using primers designed to amplify the pCPF4969 variable region.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Shown are results using DNA specimens from strains (PB-1, 3441, TGII002 and TGII003), which carries the variant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gene or from F4969 and F5603, which are strains carrying the classical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pe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plasmid pCPF4969 and pCPF5603 [11]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6" descr=""/>
          <p:cNvPicPr/>
          <p:nvPr/>
        </p:nvPicPr>
        <p:blipFill>
          <a:blip r:embed="rId1"/>
          <a:stretch/>
        </p:blipFill>
        <p:spPr>
          <a:xfrm>
            <a:off x="179280" y="322200"/>
            <a:ext cx="6408720" cy="5854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5:30Z</dcterms:modified>
  <cp:revision>8</cp:revision>
  <dc:subject/>
  <dc:title>スライド 1</dc:title>
</cp:coreProperties>
</file>